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0" r:id="rId2"/>
    <p:sldId id="292" r:id="rId3"/>
    <p:sldId id="293" r:id="rId4"/>
    <p:sldId id="298" r:id="rId5"/>
    <p:sldId id="297" r:id="rId6"/>
    <p:sldId id="288" r:id="rId7"/>
  </p:sldIdLst>
  <p:sldSz cx="6858000" cy="9906000" type="A4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oshibu, Kyoko" initials="KK" lastIdx="1" clrIdx="0">
    <p:extLst>
      <p:ext uri="{19B8F6BF-5375-455C-9EA6-DF929625EA0E}">
        <p15:presenceInfo xmlns:p15="http://schemas.microsoft.com/office/powerpoint/2012/main" userId="S-1-5-21-1009579374-2342361561-4147951735-1764107" providerId="AD"/>
      </p:ext>
    </p:extLst>
  </p:cmAuthor>
  <p:cmAuthor id="2" name="Alijevic, Omar (contracted)" initials="AO(" lastIdx="1" clrIdx="1">
    <p:extLst>
      <p:ext uri="{19B8F6BF-5375-455C-9EA6-DF929625EA0E}">
        <p15:presenceInfo xmlns:p15="http://schemas.microsoft.com/office/powerpoint/2012/main" userId="S-1-5-21-1009579374-2342361561-4147951735-183622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194" autoAdjust="0"/>
    <p:restoredTop sz="94660"/>
  </p:normalViewPr>
  <p:slideViewPr>
    <p:cSldViewPr snapToGrid="0">
      <p:cViewPr>
        <p:scale>
          <a:sx n="125" d="100"/>
          <a:sy n="125" d="100"/>
        </p:scale>
        <p:origin x="797" y="-287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37658929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3082518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284359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3028501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2102568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066683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542395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693451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3471570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32538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717552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EFB70-9FB2-4A56-AC11-EA3A742CF0C0}" type="datetimeFigureOut">
              <a:rPr lang="fr-CH" smtClean="0"/>
              <a:t>09.02.2022</a:t>
            </a:fld>
            <a:endParaRPr lang="fr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E70CA7-3505-424E-871F-E5F79ADAAF6F}" type="slidenum">
              <a:rPr lang="fr-CH" smtClean="0"/>
              <a:t>‹#›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4069328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03826" y="1943906"/>
            <a:ext cx="5116658" cy="6257445"/>
            <a:chOff x="1003826" y="1943906"/>
            <a:chExt cx="5116658" cy="625744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82570" y="1943906"/>
              <a:ext cx="3892670" cy="3599498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1003826" y="6077693"/>
              <a:ext cx="5116658" cy="21236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1. A list of tolerability parameters</a:t>
              </a:r>
            </a:p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parameters and scores for passive signs and manipulations for the tolerability test are summarized. On days 1 and 2, the mice were scored for these parameters at 15 min, 2 h, and 4 h after administration. The animals were scored from 0 to 2: 0 = normal activity, 1 = moderate abnormalities, and 2 = severe abnormalities. This scoring system was used for all parameters with the exception of locomotor activity, provoked biting, touch escape, and struggle when held by the tail. For these 4 parameters, the scale was: 0 = normal activity and 1 = abnormal activity, with A indicating an increase and B a decrease in the respective activities.</a:t>
              </a:r>
            </a:p>
            <a:p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131314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234285" y="518274"/>
            <a:ext cx="6214246" cy="9179215"/>
            <a:chOff x="234285" y="518274"/>
            <a:chExt cx="6214246" cy="9179215"/>
          </a:xfrm>
        </p:grpSpPr>
        <p:sp>
          <p:nvSpPr>
            <p:cNvPr id="5" name="TextBox 4"/>
            <p:cNvSpPr txBox="1"/>
            <p:nvPr/>
          </p:nvSpPr>
          <p:spPr>
            <a:xfrm>
              <a:off x="234285" y="9420490"/>
              <a:ext cx="24305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702321" y="518274"/>
              <a:ext cx="5746210" cy="8870870"/>
              <a:chOff x="702321" y="518274"/>
              <a:chExt cx="5746210" cy="8870870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702321" y="518274"/>
                <a:ext cx="5746210" cy="8870870"/>
                <a:chOff x="702321" y="518274"/>
                <a:chExt cx="5746210" cy="8870870"/>
              </a:xfrm>
            </p:grpSpPr>
            <p:sp>
              <p:nvSpPr>
                <p:cNvPr id="6" name="TextBox 5"/>
                <p:cNvSpPr txBox="1"/>
                <p:nvPr/>
              </p:nvSpPr>
              <p:spPr>
                <a:xfrm>
                  <a:off x="846283" y="671895"/>
                  <a:ext cx="30970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/>
                    <a:t>A</a:t>
                  </a:r>
                  <a:endParaRPr lang="fr-CH" sz="1600" b="1" dirty="0"/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846283" y="3528346"/>
                  <a:ext cx="30328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 smtClean="0"/>
                    <a:t>B</a:t>
                  </a:r>
                  <a:endParaRPr lang="fr-CH" sz="1600" b="1" dirty="0"/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851092" y="6385487"/>
                  <a:ext cx="29367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 smtClean="0"/>
                    <a:t>C</a:t>
                  </a:r>
                  <a:endParaRPr lang="fr-CH" sz="1600" b="1" dirty="0"/>
                </a:p>
              </p:txBody>
            </p:sp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702324" y="518274"/>
                  <a:ext cx="5723347" cy="3177879"/>
                </a:xfrm>
                <a:prstGeom prst="rect">
                  <a:avLst/>
                </a:prstGeom>
              </p:spPr>
            </p:pic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763288" y="3375246"/>
                  <a:ext cx="5685243" cy="3193121"/>
                </a:xfrm>
                <a:prstGeom prst="rect">
                  <a:avLst/>
                </a:prstGeom>
              </p:spPr>
            </p:pic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02321" y="6196023"/>
                  <a:ext cx="5746210" cy="3193121"/>
                </a:xfrm>
                <a:prstGeom prst="rect">
                  <a:avLst/>
                </a:prstGeom>
              </p:spPr>
            </p:pic>
          </p:grpSp>
          <p:sp>
            <p:nvSpPr>
              <p:cNvPr id="3" name="Rectangle 2"/>
              <p:cNvSpPr/>
              <p:nvPr/>
            </p:nvSpPr>
            <p:spPr>
              <a:xfrm>
                <a:off x="4075611" y="1227909"/>
                <a:ext cx="235132" cy="35269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H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636277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03826" y="2652848"/>
            <a:ext cx="511665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l movement in the open-field activity test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otal distance traveled, (B) total time of movement, and (C) total number of rears during the 30-min open-field test period are shown for all compounds. The 4 doses at which the test compounds were used are represented in black: 0 (vehicle); white: low dose; light grey: medium dose; and dark grey: high dose. The specific doses for each compound (in mg/kg) are indicated in each graph next to the test compound name on the x-axis. N = 4 mice. Data are presented as mean ± S.D. </a:t>
            </a:r>
          </a:p>
          <a:p>
            <a:endParaRPr lang="fr-CH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50297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67603" y="2499359"/>
            <a:ext cx="5285668" cy="6043868"/>
            <a:chOff x="967603" y="2499359"/>
            <a:chExt cx="5285668" cy="6043868"/>
          </a:xfrm>
        </p:grpSpPr>
        <p:sp>
          <p:nvSpPr>
            <p:cNvPr id="3" name="TextBox 2"/>
            <p:cNvSpPr txBox="1"/>
            <p:nvPr/>
          </p:nvSpPr>
          <p:spPr>
            <a:xfrm>
              <a:off x="1136613" y="6604235"/>
              <a:ext cx="5116658" cy="19389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3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Body temperature over time after a single i.p. injection of nicotine or anatabine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time course of change in body temperature during the tolerability assessment is presented for vehicle control (a black line with black circles), nicotine 0.25 mg/kg (a light blue line with triangles), nicotine 0.5 mg/kg (a dotted blue line with triangles), nicotine 1 mg/kg (a blue line with triangles), anatabine 1 mg/kg (a yellow line with crosses), anatabine 2 mg/kg (a red dotted line with crosses) and anatabine 4 mg/kg (a red line with crosses). N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 4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ce;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 smtClean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*</a:t>
              </a:r>
              <a:r>
                <a:rPr lang="en-US" sz="1200" dirty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p &lt; </a:t>
              </a:r>
              <a:r>
                <a:rPr lang="en-US" sz="1200" dirty="0" smtClean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0.05.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ta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e presented as mean ±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. 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5" name="Group 14"/>
            <p:cNvGrpSpPr/>
            <p:nvPr/>
          </p:nvGrpSpPr>
          <p:grpSpPr>
            <a:xfrm>
              <a:off x="967603" y="2499359"/>
              <a:ext cx="5029636" cy="3563823"/>
              <a:chOff x="967603" y="2499359"/>
              <a:chExt cx="5029636" cy="3563823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2"/>
              <a:srcRect t="9229"/>
              <a:stretch/>
            </p:blipFill>
            <p:spPr>
              <a:xfrm>
                <a:off x="967603" y="2499359"/>
                <a:ext cx="5029636" cy="3563823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3248598" y="3755136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*</a:t>
                </a:r>
                <a:endParaRPr lang="fr-CH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3248598" y="4210328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*</a:t>
                </a:r>
                <a:endParaRPr lang="fr-CH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670403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76694" y="2533217"/>
            <a:ext cx="5568483" cy="5273875"/>
            <a:chOff x="876694" y="2533217"/>
            <a:chExt cx="5568483" cy="5273875"/>
          </a:xfrm>
        </p:grpSpPr>
        <p:sp>
          <p:nvSpPr>
            <p:cNvPr id="25" name="TextBox 24"/>
            <p:cNvSpPr txBox="1"/>
            <p:nvPr/>
          </p:nvSpPr>
          <p:spPr>
            <a:xfrm>
              <a:off x="876694" y="6422097"/>
              <a:ext cx="5568483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Supplementary Figure </a:t>
              </a:r>
              <a:r>
                <a:rPr lang="en-US" sz="1200" b="1" dirty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4</a:t>
              </a:r>
              <a:r>
                <a:rPr lang="en-US" sz="1200" b="1" dirty="0" smtClean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. Effect of buspirone in the zebrafish NTT </a:t>
              </a:r>
            </a:p>
            <a:p>
              <a:pPr algn="just"/>
              <a:r>
                <a:rPr lang="en-US" sz="1200" dirty="0" smtClean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(A) Time spent at the top, (B) time spent at the bottom, (C) total distance travelled, and (D) freezing time are shown for buspirone (10, 30, and 100 mg/L). Buspirone increased the time spent at the top for all three doses, decreased the time spent at the bottom for two lower doses. Only fish treated with 100 mg/L showed reduced total distance travelled and increased freezing time. </a:t>
              </a:r>
              <a:r>
                <a:rPr lang="en-US" sz="1200" dirty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Solid circles = males; open circles = females; n = </a:t>
              </a:r>
              <a:r>
                <a:rPr lang="en-US" sz="1200" dirty="0" smtClean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12–24; </a:t>
              </a:r>
              <a:r>
                <a:rPr lang="en-US" sz="1200" dirty="0">
                  <a:solidFill>
                    <a:srgbClr val="0000FF"/>
                  </a:solidFill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*</a:t>
              </a:r>
              <a:r>
                <a:rPr lang="en-US" sz="1200" dirty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p &lt; 0.05 and </a:t>
              </a:r>
              <a:r>
                <a:rPr lang="en-US" sz="1200" dirty="0">
                  <a:solidFill>
                    <a:srgbClr val="0000FF"/>
                  </a:solidFill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***</a:t>
              </a:r>
              <a:r>
                <a:rPr lang="en-US" sz="1200" dirty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p &lt; </a:t>
              </a:r>
              <a:r>
                <a:rPr lang="en-US" sz="1200" dirty="0" smtClean="0">
                  <a:latin typeface="Times New Roman" panose="02020603050405020304" pitchFamily="18" charset="0"/>
                  <a:ea typeface="Open Sans" panose="020B0606030504020204" pitchFamily="34" charset="0"/>
                  <a:cs typeface="Times New Roman" panose="02020603050405020304" pitchFamily="18" charset="0"/>
                </a:rPr>
                <a:t>0.001.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ata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e presented as mean ± SD. 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367353" y="2533217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A</a:t>
              </a:r>
              <a:endParaRPr lang="fr-CH" sz="1600" b="1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360854" y="2533217"/>
              <a:ext cx="3000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B</a:t>
              </a:r>
              <a:endParaRPr lang="fr-CH" sz="16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375368" y="4311229"/>
              <a:ext cx="2936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C</a:t>
              </a:r>
              <a:endParaRPr lang="fr-CH" sz="1600" b="1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353640" y="4311229"/>
              <a:ext cx="31451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D</a:t>
              </a:r>
              <a:endParaRPr lang="fr-CH" sz="1600" b="1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918271" y="2579384"/>
              <a:ext cx="13805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spent at the top</a:t>
              </a:r>
              <a:endParaRPr lang="fr-CH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118220" y="4357396"/>
              <a:ext cx="9781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distance</a:t>
              </a:r>
              <a:endParaRPr lang="fr-CH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726592" y="2579384"/>
              <a:ext cx="15937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spent at the bottom</a:t>
              </a:r>
              <a:endParaRPr lang="fr-CH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4082143" y="4357396"/>
              <a:ext cx="9589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reezing time</a:t>
              </a:r>
              <a:endParaRPr lang="fr-CH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t="20061"/>
            <a:stretch/>
          </p:blipFill>
          <p:spPr>
            <a:xfrm>
              <a:off x="1343144" y="2819399"/>
              <a:ext cx="2424498" cy="1564851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/>
            <a:srcRect t="19583"/>
            <a:stretch/>
          </p:blipFill>
          <p:spPr>
            <a:xfrm>
              <a:off x="3281353" y="2814638"/>
              <a:ext cx="2409587" cy="1564532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4"/>
            <a:srcRect t="20621"/>
            <a:stretch/>
          </p:blipFill>
          <p:spPr>
            <a:xfrm>
              <a:off x="1280048" y="4576763"/>
              <a:ext cx="2482502" cy="1555959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5"/>
            <a:srcRect t="19271"/>
            <a:stretch/>
          </p:blipFill>
          <p:spPr>
            <a:xfrm>
              <a:off x="3284978" y="4552949"/>
              <a:ext cx="2418757" cy="157500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998624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26460" y="2113162"/>
            <a:ext cx="6005080" cy="6293602"/>
            <a:chOff x="426460" y="2113162"/>
            <a:chExt cx="6005080" cy="6293602"/>
          </a:xfrm>
        </p:grpSpPr>
        <p:sp>
          <p:nvSpPr>
            <p:cNvPr id="35" name="TextBox 34"/>
            <p:cNvSpPr txBox="1"/>
            <p:nvPr/>
          </p:nvSpPr>
          <p:spPr>
            <a:xfrm>
              <a:off x="1003826" y="7391101"/>
              <a:ext cx="5116658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5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s of alkaloids on nicotinic acetylcholine receptor binding in vitro</a:t>
              </a:r>
            </a:p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nding of nicotine, cotinine, and anatabine were tested against </a:t>
              </a:r>
              <a:r>
                <a:rPr lang="el-G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3β4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A, B, C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el-G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α4β2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l-G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, E, F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el-G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l-G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7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icotinic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tylcholine receptor (G, H, I). Mean IC</a:t>
              </a:r>
              <a:r>
                <a:rPr lang="en-US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alues (in µM) are indicated in the graphs. N = 3 repeats.</a:t>
              </a: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6460" y="2113162"/>
              <a:ext cx="6005080" cy="504792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879410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36</TotalTime>
  <Words>611</Words>
  <Application>Microsoft Office PowerPoint</Application>
  <PresentationFormat>A4 Paper (210x297 mm)</PresentationFormat>
  <Paragraphs>2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Open San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hilip Morris Internationa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shibu, Kyoko</dc:creator>
  <cp:lastModifiedBy>Alijevic, Omar</cp:lastModifiedBy>
  <cp:revision>257</cp:revision>
  <cp:lastPrinted>2020-10-20T10:38:01Z</cp:lastPrinted>
  <dcterms:created xsi:type="dcterms:W3CDTF">2019-07-16T10:16:06Z</dcterms:created>
  <dcterms:modified xsi:type="dcterms:W3CDTF">2022-02-09T22:10:44Z</dcterms:modified>
</cp:coreProperties>
</file>